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379"/>
    <p:restoredTop sz="91633" autoAdjust="0"/>
  </p:normalViewPr>
  <p:slideViewPr>
    <p:cSldViewPr snapToGrid="0">
      <p:cViewPr varScale="1">
        <p:scale>
          <a:sx n="58" d="100"/>
          <a:sy n="58" d="100"/>
        </p:scale>
        <p:origin x="676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263B18-DE5A-B94B-8CD6-7D5ABE0200E7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01DE3C-3B47-D34D-8EFC-CE3A4074186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9527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01DE3C-3B47-D34D-8EFC-CE3A4074186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69535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01DE3C-3B47-D34D-8EFC-CE3A40741867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55144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FE98058-CF7B-7A18-3B67-62CAEF2036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AF990ED-AE13-FAED-5D11-34E93DA959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1F91D8E-9B36-F47B-610E-58D9E23B8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5F0603C-3C65-C5A8-58F0-61C7A34FC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99552D-8F66-79E8-1B6B-CF185C613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0352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01D354-837C-A7A4-4F97-377FCAA473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6E6850-DFF9-8DCB-7DED-25F0DCE53B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E9EB7B2-FC15-DE93-A0A0-51D3FFF15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9EA95EB-9457-E9A9-A0AE-E9FF2E575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8234492-7D3B-F9E8-3922-6F557DA0F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1393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D6B54DC-A765-5355-96F8-4B8B882E82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9F425C4-E2F5-101F-02DE-376383F35A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8E6571E-BB99-A70E-F874-84B52913A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1548F20-EA3F-F74F-9B7B-FC1CAFAAC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9512916-6317-DDCD-905C-97721AFC5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5525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30EE24-516C-ECAB-7AF0-72E2FE9B9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2C3A038-BCF6-B5A4-7C2A-392E800D50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D654B1-3575-FA54-778E-649B1F92B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93C22EE-D6A4-A19A-BFB3-551C57DA3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85A968-8A8E-D313-AFD3-B59291B37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3243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57B9471-3461-98EC-F27B-3B67F1AC6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34F1717-952E-CFFB-2517-7C8779CD7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0A582A4-1BAA-4991-C3B0-E6898719B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018DE2-BE4D-F3C0-AE13-820F51EA3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C9299E-CE0C-4ADA-26DA-A1742CBB5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798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242017-81B5-30A0-3957-6F1CF327C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842A9A8-61E8-C41F-6CC7-7798DA4ACC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094DC50-5EB9-6738-D90C-42E6D1FCE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7C5AF77-4293-3C6E-9B87-492FB6AD8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BF99B3E-AD13-152E-364C-9418D0D3F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7E0E90D-2B78-BDFD-83A3-9199C937B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5141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01EAF7F-37EC-62C5-A57C-B47450229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3A0008B-22DB-790F-8661-680E5E647F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241C267-28C6-9EE3-706F-A6D5D92595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0364217-9B9B-27E7-783B-10DA035F5D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8F14117-5D06-0F6F-A6EA-A7526D76CB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618126B-8E48-8F27-064C-9FA2B5AEC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2D74ACF-153F-E2D5-792E-04888238C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9D892BF-B4ED-B962-E4EB-47BCF70670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8826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075A836-9DAF-8242-63A4-EAE5CA535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1AB53C4-FC22-CB67-BA27-DD424C5F28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AD71EFB-6747-3A42-0493-B1473D600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AE63645-C700-4F9B-187A-BB2C0CA05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4029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0F422E8-9366-39D0-7991-CEA256C8F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71CAE62-E2E9-8AB4-AECD-6F6F25178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CA267F3-044B-AB9A-0752-04CCA3E66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6619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4994220-2905-E742-B90E-3FA2392FA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C20D4F4-7D4D-BFB5-6371-27BED557F2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350AAE9-7258-E3C4-73C8-821D979AB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C9B397F-0324-49A0-2A90-08D723C28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AC4522D-B04C-9CCA-7063-C9F915FA5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339B369-8267-9109-29C7-A21672FAD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8675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134835C-0FAF-4FFA-31E8-9019DC9120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614BE19-A3D4-3C4A-BDE6-2F406A613E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D36ED61-AD1E-BE5A-F3FE-6165650636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3E9EA87-5024-F91D-50BD-AE2E542AF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4DEF3A6-AB18-D9CF-345E-5110BA1EB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418287E-0C34-1AD1-1863-C2BD09FF6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337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9999F3F-1971-FFA6-BDC8-B0CEE29E3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6059AB0-203A-5C0A-007F-C2B74551E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D2EFD14-6B97-EE3C-1BD7-E0FCA11F29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63B5C3-1F6B-0246-8AA2-3259EA32B48A}" type="datetimeFigureOut">
              <a:rPr lang="fr-FR" smtClean="0"/>
              <a:t>14/1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5AD010-148E-244E-3BFC-5AFF127147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BDA22B6-8A01-1141-8D0A-36064F00FB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3F358-E582-8143-B0EF-EFB96E59A8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970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A996A525-14A7-56A4-6AAF-F418AAE318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71" b="28003"/>
          <a:stretch/>
        </p:blipFill>
        <p:spPr>
          <a:xfrm>
            <a:off x="1908751" y="1008261"/>
            <a:ext cx="9046792" cy="3721002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id="{A3D5FB14-7A89-E660-688F-AE1FE7DDE329}"/>
              </a:ext>
            </a:extLst>
          </p:cNvPr>
          <p:cNvSpPr txBox="1"/>
          <p:nvPr/>
        </p:nvSpPr>
        <p:spPr>
          <a:xfrm>
            <a:off x="1411499" y="3704952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3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C4046DC-B4F6-8B8C-9622-5F05A7739721}"/>
              </a:ext>
            </a:extLst>
          </p:cNvPr>
          <p:cNvSpPr txBox="1"/>
          <p:nvPr/>
        </p:nvSpPr>
        <p:spPr>
          <a:xfrm rot="16200000">
            <a:off x="77736" y="2759822"/>
            <a:ext cx="1890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Relative Light Unit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3FDC015F-8634-D85C-F579-3AD0C3E97736}"/>
              </a:ext>
            </a:extLst>
          </p:cNvPr>
          <p:cNvSpPr txBox="1"/>
          <p:nvPr/>
        </p:nvSpPr>
        <p:spPr>
          <a:xfrm>
            <a:off x="1411499" y="3034618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4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D93C35D5-ECCE-E30E-17E2-F43B1EAAD6AF}"/>
              </a:ext>
            </a:extLst>
          </p:cNvPr>
          <p:cNvSpPr txBox="1"/>
          <p:nvPr/>
        </p:nvSpPr>
        <p:spPr>
          <a:xfrm>
            <a:off x="1411499" y="2364284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5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F558977C-B024-7EC8-761A-31243332BD03}"/>
              </a:ext>
            </a:extLst>
          </p:cNvPr>
          <p:cNvSpPr txBox="1"/>
          <p:nvPr/>
        </p:nvSpPr>
        <p:spPr>
          <a:xfrm>
            <a:off x="1411499" y="1693950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6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3E4F02AC-8112-2F76-93B3-9F056387AC6E}"/>
              </a:ext>
            </a:extLst>
          </p:cNvPr>
          <p:cNvSpPr txBox="1"/>
          <p:nvPr/>
        </p:nvSpPr>
        <p:spPr>
          <a:xfrm>
            <a:off x="1411499" y="1023616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7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F652A26F-2D17-731B-AA99-92B555F3EE3C}"/>
              </a:ext>
            </a:extLst>
          </p:cNvPr>
          <p:cNvSpPr txBox="1"/>
          <p:nvPr/>
        </p:nvSpPr>
        <p:spPr>
          <a:xfrm>
            <a:off x="1411499" y="4375286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A3D5D2A1-2694-C717-1483-72E3E9CC9184}"/>
              </a:ext>
            </a:extLst>
          </p:cNvPr>
          <p:cNvSpPr txBox="1"/>
          <p:nvPr/>
        </p:nvSpPr>
        <p:spPr>
          <a:xfrm>
            <a:off x="2046817" y="4694146"/>
            <a:ext cx="13583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n </a:t>
            </a:r>
            <a:r>
              <a:rPr lang="fr-FR" sz="1400" dirty="0" err="1"/>
              <a:t>exposed</a:t>
            </a:r>
            <a:r>
              <a:rPr lang="fr-FR" sz="1400" dirty="0"/>
              <a:t> bovine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C149923D-D753-6D33-59EA-308F57B1C381}"/>
              </a:ext>
            </a:extLst>
          </p:cNvPr>
          <p:cNvSpPr txBox="1"/>
          <p:nvPr/>
        </p:nvSpPr>
        <p:spPr>
          <a:xfrm>
            <a:off x="3485119" y="4694146"/>
            <a:ext cx="13583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/>
              <a:t>Exp</a:t>
            </a:r>
            <a:r>
              <a:rPr lang="fr-FR" sz="1400" dirty="0"/>
              <a:t>. </a:t>
            </a:r>
            <a:r>
              <a:rPr lang="fr-FR" sz="1400" dirty="0" err="1"/>
              <a:t>Infected</a:t>
            </a:r>
            <a:r>
              <a:rPr lang="fr-FR" sz="1400" dirty="0"/>
              <a:t> bovine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48F85118-46B2-AB24-3AF3-D0DC03F9DA0F}"/>
              </a:ext>
            </a:extLst>
          </p:cNvPr>
          <p:cNvSpPr txBox="1"/>
          <p:nvPr/>
        </p:nvSpPr>
        <p:spPr>
          <a:xfrm>
            <a:off x="9499290" y="4694146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 GP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B0DC307F-F6A3-697A-FFE1-940BFDDBA14E}"/>
              </a:ext>
            </a:extLst>
          </p:cNvPr>
          <p:cNvSpPr txBox="1"/>
          <p:nvPr/>
        </p:nvSpPr>
        <p:spPr>
          <a:xfrm>
            <a:off x="8001172" y="4694146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 </a:t>
            </a:r>
            <a:r>
              <a:rPr lang="fr-FR" sz="1400" dirty="0" err="1"/>
              <a:t>serum</a:t>
            </a:r>
            <a:endParaRPr lang="fr-FR" sz="1400" dirty="0"/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F9245FEC-510D-04E3-AAE7-367620DE40FC}"/>
              </a:ext>
            </a:extLst>
          </p:cNvPr>
          <p:cNvSpPr txBox="1"/>
          <p:nvPr/>
        </p:nvSpPr>
        <p:spPr>
          <a:xfrm>
            <a:off x="4901289" y="4694146"/>
            <a:ext cx="1277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Anti CCHFV-</a:t>
            </a:r>
            <a:r>
              <a:rPr lang="fr-FR" sz="1400" dirty="0" err="1"/>
              <a:t>Gc</a:t>
            </a:r>
            <a:endParaRPr lang="fr-FR" sz="1400" dirty="0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DF501FAA-F9B7-7212-1C12-48FF59C5AD09}"/>
              </a:ext>
            </a:extLst>
          </p:cNvPr>
          <p:cNvSpPr txBox="1"/>
          <p:nvPr/>
        </p:nvSpPr>
        <p:spPr>
          <a:xfrm>
            <a:off x="6602999" y="4694146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Anti VSV-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DA09F3E-6691-44EC-B9B5-D68C8F2728B7}"/>
              </a:ext>
            </a:extLst>
          </p:cNvPr>
          <p:cNvSpPr txBox="1"/>
          <p:nvPr/>
        </p:nvSpPr>
        <p:spPr>
          <a:xfrm>
            <a:off x="22035" y="5299111"/>
            <a:ext cx="1210753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800" b="1" dirty="0" err="1">
                <a:latin typeface="+mn-lt"/>
              </a:rPr>
              <a:t>Supplementary</a:t>
            </a:r>
            <a:r>
              <a:rPr lang="fr-FR" sz="1800" b="1" dirty="0">
                <a:latin typeface="+mn-lt"/>
              </a:rPr>
              <a:t> figure 1: </a:t>
            </a:r>
            <a:r>
              <a:rPr lang="en-US" sz="1800" dirty="0"/>
              <a:t>Specificity assessment of the CCHFV </a:t>
            </a:r>
            <a:r>
              <a:rPr lang="en-US" sz="1800" dirty="0" err="1"/>
              <a:t>tcVLP</a:t>
            </a:r>
            <a:r>
              <a:rPr lang="en-US" sz="1800" dirty="0"/>
              <a:t>-based neutralization assa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 err="1"/>
              <a:t>tecVLPs</a:t>
            </a:r>
            <a:r>
              <a:rPr lang="en-US" sz="1800" dirty="0"/>
              <a:t> were pre-incubated sera sampled on French bovine (Non-exposed bovine), serum from an experimentally infected bovine (Exp. Infected bovine), with the anti-Gc neutralizing 11E7 </a:t>
            </a:r>
            <a:r>
              <a:rPr lang="en-US" sz="1800" dirty="0" err="1"/>
              <a:t>mAb</a:t>
            </a:r>
            <a:r>
              <a:rPr lang="en-US" sz="1800" dirty="0"/>
              <a:t> (anti CCHFV-Gc, the anti-VSV-G neutralizing 41A1 antibody (anti VSV-G), or in the absence of antibodies (No serum). CCHFV </a:t>
            </a:r>
            <a:r>
              <a:rPr lang="en-US" sz="1800" dirty="0" err="1"/>
              <a:t>tecVLPs</a:t>
            </a:r>
            <a:r>
              <a:rPr lang="en-US" sz="1800" dirty="0"/>
              <a:t> generated without glycoproteins were used to determine luciferase signal thresholds (</a:t>
            </a:r>
            <a:r>
              <a:rPr lang="en-US" sz="1800" dirty="0" err="1"/>
              <a:t>noGP</a:t>
            </a:r>
            <a:r>
              <a:rPr lang="en-US" sz="1800" dirty="0"/>
              <a:t>). </a:t>
            </a:r>
            <a:r>
              <a:rPr lang="fr-FR" sz="1800" dirty="0" err="1"/>
              <a:t>Dotted</a:t>
            </a:r>
            <a:r>
              <a:rPr lang="fr-FR" sz="1800" dirty="0"/>
              <a:t> line </a:t>
            </a:r>
            <a:r>
              <a:rPr lang="fr-FR" sz="1800" dirty="0" err="1"/>
              <a:t>represent</a:t>
            </a:r>
            <a:r>
              <a:rPr lang="fr-FR" sz="1800" dirty="0"/>
              <a:t> the </a:t>
            </a:r>
            <a:r>
              <a:rPr lang="fr-FR" sz="1800" dirty="0" err="1"/>
              <a:t>threshold</a:t>
            </a:r>
            <a:r>
              <a:rPr lang="fr-FR" sz="1800" dirty="0"/>
              <a:t> value</a:t>
            </a:r>
            <a:r>
              <a:rPr lang="en-US" sz="1800" dirty="0"/>
              <a:t>.</a:t>
            </a:r>
            <a:endParaRPr lang="fr-FR" dirty="0"/>
          </a:p>
          <a:p>
            <a:endParaRPr lang="en-GB" dirty="0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FB6D5450-0CB3-42D4-A1BD-201615BE48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643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>
            <a:extLst>
              <a:ext uri="{FF2B5EF4-FFF2-40B4-BE49-F238E27FC236}">
                <a16:creationId xmlns:a16="http://schemas.microsoft.com/office/drawing/2014/main" id="{797A829B-331F-C7F6-8C82-F392D6E2BC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169" b="31924"/>
          <a:stretch/>
        </p:blipFill>
        <p:spPr>
          <a:xfrm>
            <a:off x="1824321" y="625773"/>
            <a:ext cx="8971491" cy="4106791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EDBC90F6-8682-2588-1512-E8BBC80B43B1}"/>
              </a:ext>
            </a:extLst>
          </p:cNvPr>
          <p:cNvSpPr txBox="1"/>
          <p:nvPr/>
        </p:nvSpPr>
        <p:spPr>
          <a:xfrm>
            <a:off x="1473052" y="3438047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3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09304F5-0199-7E6A-28B0-D6C1337C7B9D}"/>
              </a:ext>
            </a:extLst>
          </p:cNvPr>
          <p:cNvSpPr txBox="1"/>
          <p:nvPr/>
        </p:nvSpPr>
        <p:spPr>
          <a:xfrm rot="16200000">
            <a:off x="198923" y="2429309"/>
            <a:ext cx="1890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Relative Light Unit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F7CCBD0-4ECB-415D-93E9-585148F4FC1A}"/>
              </a:ext>
            </a:extLst>
          </p:cNvPr>
          <p:cNvSpPr txBox="1"/>
          <p:nvPr/>
        </p:nvSpPr>
        <p:spPr>
          <a:xfrm>
            <a:off x="1473052" y="2751811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4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FD84ACB-D372-4CE2-662C-45F6A32EF494}"/>
              </a:ext>
            </a:extLst>
          </p:cNvPr>
          <p:cNvSpPr txBox="1"/>
          <p:nvPr/>
        </p:nvSpPr>
        <p:spPr>
          <a:xfrm>
            <a:off x="1473052" y="2065575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5295EE9F-AE8C-FE1C-0FB4-830A60CF65BE}"/>
              </a:ext>
            </a:extLst>
          </p:cNvPr>
          <p:cNvSpPr txBox="1"/>
          <p:nvPr/>
        </p:nvSpPr>
        <p:spPr>
          <a:xfrm>
            <a:off x="1473052" y="1379339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6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A9732CC-435B-E1E6-DC8F-95348CB05679}"/>
              </a:ext>
            </a:extLst>
          </p:cNvPr>
          <p:cNvSpPr txBox="1"/>
          <p:nvPr/>
        </p:nvSpPr>
        <p:spPr>
          <a:xfrm>
            <a:off x="1473051" y="693102"/>
            <a:ext cx="1005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7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799DDD00-9658-0301-E019-EBD1C2AB0C25}"/>
              </a:ext>
            </a:extLst>
          </p:cNvPr>
          <p:cNvSpPr txBox="1"/>
          <p:nvPr/>
        </p:nvSpPr>
        <p:spPr>
          <a:xfrm>
            <a:off x="1473052" y="4124285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10</a:t>
            </a:r>
            <a:r>
              <a:rPr lang="fr-FR" baseline="30000" dirty="0"/>
              <a:t>2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B0FBB53-037C-DCA5-14D2-CEE959B9C2D2}"/>
              </a:ext>
            </a:extLst>
          </p:cNvPr>
          <p:cNvSpPr txBox="1"/>
          <p:nvPr/>
        </p:nvSpPr>
        <p:spPr>
          <a:xfrm>
            <a:off x="2010557" y="4424787"/>
            <a:ext cx="1358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ELISA</a:t>
            </a:r>
            <a:r>
              <a:rPr lang="fr-FR" sz="1400" baseline="30000" dirty="0"/>
              <a:t>+ </a:t>
            </a:r>
            <a:r>
              <a:rPr lang="fr-FR" sz="1400" dirty="0"/>
              <a:t>bovine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38C7F736-3702-12DE-A5AF-FABB9387EFF0}"/>
              </a:ext>
            </a:extLst>
          </p:cNvPr>
          <p:cNvSpPr txBox="1"/>
          <p:nvPr/>
        </p:nvSpPr>
        <p:spPr>
          <a:xfrm>
            <a:off x="8168147" y="4424787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 </a:t>
            </a:r>
            <a:r>
              <a:rPr lang="fr-FR" sz="1400" dirty="0" err="1"/>
              <a:t>serum</a:t>
            </a:r>
            <a:endParaRPr lang="fr-FR" sz="1400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F5A43B40-9803-D372-6DDA-C4B3DE01A580}"/>
              </a:ext>
            </a:extLst>
          </p:cNvPr>
          <p:cNvSpPr txBox="1"/>
          <p:nvPr/>
        </p:nvSpPr>
        <p:spPr>
          <a:xfrm>
            <a:off x="7077988" y="4424787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Anti VSV-G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C5B09F0-1CD1-8771-34BA-A55FC61611B6}"/>
              </a:ext>
            </a:extLst>
          </p:cNvPr>
          <p:cNvSpPr txBox="1"/>
          <p:nvPr/>
        </p:nvSpPr>
        <p:spPr>
          <a:xfrm>
            <a:off x="5707431" y="4424787"/>
            <a:ext cx="1252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Anti CCHFV-</a:t>
            </a:r>
            <a:r>
              <a:rPr lang="fr-FR" sz="1400" dirty="0" err="1"/>
              <a:t>Gc</a:t>
            </a:r>
            <a:endParaRPr lang="fr-FR" sz="1400" dirty="0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DA611AC-0AF2-83A0-9F15-B9B71262914B}"/>
              </a:ext>
            </a:extLst>
          </p:cNvPr>
          <p:cNvSpPr txBox="1"/>
          <p:nvPr/>
        </p:nvSpPr>
        <p:spPr>
          <a:xfrm>
            <a:off x="9537931" y="4424787"/>
            <a:ext cx="10721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 Gp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9DBB6DC-9B1A-E7BD-BD12-E2BF03AB748C}"/>
              </a:ext>
            </a:extLst>
          </p:cNvPr>
          <p:cNvSpPr txBox="1"/>
          <p:nvPr/>
        </p:nvSpPr>
        <p:spPr>
          <a:xfrm>
            <a:off x="3206512" y="4424787"/>
            <a:ext cx="1358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ELISA</a:t>
            </a:r>
            <a:r>
              <a:rPr lang="fr-FR" sz="1400" baseline="30000" dirty="0"/>
              <a:t>- </a:t>
            </a:r>
            <a:r>
              <a:rPr lang="fr-FR" sz="1400" dirty="0"/>
              <a:t>bovine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0E190F6E-A4E4-1AB5-0DCD-BBF3736CBEF7}"/>
              </a:ext>
            </a:extLst>
          </p:cNvPr>
          <p:cNvSpPr txBox="1"/>
          <p:nvPr/>
        </p:nvSpPr>
        <p:spPr>
          <a:xfrm>
            <a:off x="4415128" y="4424787"/>
            <a:ext cx="135834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Non </a:t>
            </a:r>
            <a:r>
              <a:rPr lang="fr-FR" sz="1400" dirty="0" err="1"/>
              <a:t>exposed</a:t>
            </a:r>
            <a:r>
              <a:rPr lang="fr-FR" sz="1400" dirty="0"/>
              <a:t> bovine</a:t>
            </a:r>
          </a:p>
        </p:txBody>
      </p:sp>
      <p:cxnSp>
        <p:nvCxnSpPr>
          <p:cNvPr id="2" name="Connecteur droit 1">
            <a:extLst>
              <a:ext uri="{FF2B5EF4-FFF2-40B4-BE49-F238E27FC236}">
                <a16:creationId xmlns:a16="http://schemas.microsoft.com/office/drawing/2014/main" id="{51CAE36F-712B-9CFD-799A-C9770416A0B8}"/>
              </a:ext>
            </a:extLst>
          </p:cNvPr>
          <p:cNvCxnSpPr>
            <a:cxnSpLocks/>
          </p:cNvCxnSpPr>
          <p:nvPr/>
        </p:nvCxnSpPr>
        <p:spPr>
          <a:xfrm>
            <a:off x="2652203" y="902772"/>
            <a:ext cx="12334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id="{AAF2BE3A-EAA6-4688-6B90-73F3A90073ED}"/>
              </a:ext>
            </a:extLst>
          </p:cNvPr>
          <p:cNvSpPr txBox="1"/>
          <p:nvPr/>
        </p:nvSpPr>
        <p:spPr>
          <a:xfrm>
            <a:off x="3062819" y="591950"/>
            <a:ext cx="996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14D79A-B4D4-4A06-800C-32F518F08A81}"/>
              </a:ext>
            </a:extLst>
          </p:cNvPr>
          <p:cNvSpPr txBox="1"/>
          <p:nvPr/>
        </p:nvSpPr>
        <p:spPr>
          <a:xfrm>
            <a:off x="198305" y="4825382"/>
            <a:ext cx="1154567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: </a:t>
            </a:r>
            <a:r>
              <a:rPr lang="en-US" sz="1800" b="1" dirty="0"/>
              <a:t> </a:t>
            </a:r>
            <a:r>
              <a:rPr lang="en-US" sz="1800" dirty="0"/>
              <a:t>Control of unspecific </a:t>
            </a:r>
            <a:r>
              <a:rPr lang="en-US" sz="1800" dirty="0" err="1"/>
              <a:t>seroneutralizing</a:t>
            </a:r>
            <a:r>
              <a:rPr lang="en-US" sz="1800" dirty="0"/>
              <a:t> activit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/>
              <a:t>The same procedure as described in figure 3 and Fig Suppl 1 was also performed using a VSV-G </a:t>
            </a:r>
            <a:r>
              <a:rPr lang="en-US" sz="1800" dirty="0" err="1"/>
              <a:t>pseudotype</a:t>
            </a:r>
            <a:r>
              <a:rPr lang="en-US" sz="1800" dirty="0"/>
              <a:t> expressing </a:t>
            </a:r>
            <a:r>
              <a:rPr lang="en-US" sz="1800" dirty="0" err="1"/>
              <a:t>nLuc</a:t>
            </a:r>
            <a:r>
              <a:rPr lang="en-US" sz="1800" dirty="0"/>
              <a:t> to identify non-specific positive </a:t>
            </a:r>
            <a:r>
              <a:rPr lang="en-US" sz="1800" dirty="0" err="1"/>
              <a:t>seroneutralization</a:t>
            </a:r>
            <a:r>
              <a:rPr lang="en-US" sz="1800" dirty="0"/>
              <a:t>.</a:t>
            </a:r>
            <a:endParaRPr lang="fr-FR" sz="20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 err="1"/>
              <a:t>NanoLuc</a:t>
            </a:r>
            <a:r>
              <a:rPr lang="en-US" sz="1800" dirty="0"/>
              <a:t> VSV-G </a:t>
            </a:r>
            <a:r>
              <a:rPr lang="en-US" sz="1800" dirty="0" err="1"/>
              <a:t>pseudoparticules</a:t>
            </a:r>
            <a:r>
              <a:rPr lang="en-US" sz="1800" dirty="0"/>
              <a:t> were pre-incubated sera sampled on ELISA+ and ELISA- sera, French bovine (Non-exposed bovine), with the anti-Gc neutralizing 11E7 </a:t>
            </a:r>
            <a:r>
              <a:rPr lang="en-US" sz="1800" dirty="0" err="1"/>
              <a:t>mAb</a:t>
            </a:r>
            <a:r>
              <a:rPr lang="en-US" sz="1800" dirty="0"/>
              <a:t> (anti CCHFV-Gc, the anti-VSV-G neutralizing 41A1 antibody (anti VSV-G), or in the absence of antibodies (No serum). CCHFV </a:t>
            </a:r>
            <a:r>
              <a:rPr lang="en-US" sz="1800" dirty="0" err="1"/>
              <a:t>tecVLPs</a:t>
            </a:r>
            <a:r>
              <a:rPr lang="en-US" sz="1800" dirty="0"/>
              <a:t> generated without glycoproteins were used to determine luciferase signal thresholds (</a:t>
            </a:r>
            <a:r>
              <a:rPr lang="en-US" sz="1800" dirty="0" err="1"/>
              <a:t>noGP</a:t>
            </a:r>
            <a:r>
              <a:rPr lang="en-US" sz="1800" dirty="0"/>
              <a:t>). </a:t>
            </a:r>
            <a:r>
              <a:rPr lang="fr-FR" sz="1800" dirty="0" err="1"/>
              <a:t>Results</a:t>
            </a:r>
            <a:r>
              <a:rPr lang="fr-FR" sz="1800" dirty="0"/>
              <a:t> </a:t>
            </a:r>
            <a:r>
              <a:rPr lang="fr-FR" sz="1800" dirty="0" err="1"/>
              <a:t>were</a:t>
            </a:r>
            <a:r>
              <a:rPr lang="fr-FR" sz="1800" dirty="0"/>
              <a:t> </a:t>
            </a:r>
            <a:r>
              <a:rPr lang="fr-FR" sz="1800" dirty="0" err="1"/>
              <a:t>statistically</a:t>
            </a:r>
            <a:r>
              <a:rPr lang="fr-FR" sz="1800" dirty="0"/>
              <a:t> </a:t>
            </a:r>
            <a:r>
              <a:rPr lang="fr-FR" sz="1800" dirty="0" err="1"/>
              <a:t>analysed</a:t>
            </a:r>
            <a:r>
              <a:rPr lang="fr-FR" sz="1800" dirty="0"/>
              <a:t> </a:t>
            </a:r>
            <a:r>
              <a:rPr lang="fr-FR" sz="1800" dirty="0" err="1"/>
              <a:t>using</a:t>
            </a:r>
            <a:r>
              <a:rPr lang="fr-FR" sz="1800" dirty="0"/>
              <a:t> Graph Pad </a:t>
            </a:r>
            <a:r>
              <a:rPr lang="fr-FR" sz="1800" dirty="0" err="1"/>
              <a:t>Prism</a:t>
            </a:r>
            <a:r>
              <a:rPr lang="fr-FR" sz="1800" dirty="0"/>
              <a:t>, </a:t>
            </a:r>
            <a:r>
              <a:rPr lang="fr-FR" sz="1800" dirty="0" err="1"/>
              <a:t>unpaired</a:t>
            </a:r>
            <a:r>
              <a:rPr lang="fr-FR" sz="1800" dirty="0"/>
              <a:t> t test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923844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252</Words>
  <Application>Microsoft Office PowerPoint</Application>
  <PresentationFormat>Widescreen</PresentationFormat>
  <Paragraphs>35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incent LEGROS</dc:creator>
  <cp:lastModifiedBy>Huguette Simo</cp:lastModifiedBy>
  <cp:revision>8</cp:revision>
  <dcterms:created xsi:type="dcterms:W3CDTF">2022-09-30T16:49:25Z</dcterms:created>
  <dcterms:modified xsi:type="dcterms:W3CDTF">2022-11-14T13:50:32Z</dcterms:modified>
</cp:coreProperties>
</file>